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C50ED4-EE6D-4061-A6D0-A5DC7006066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3D0C37-25AF-4ACD-AE9F-2E786F1A94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7F79A9-A3A4-4ACF-AFE4-B6CCE1CFDE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DD6951-FBCC-4BD3-969E-B12CD1C50E9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8E90BB-EAB2-4741-B1FD-D8DE45927B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3B81F2-F3E1-4C87-B364-970DB2A8F3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46C594-DD7C-4EC8-A7CB-6CB9A9D1B7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0629C9-304C-464F-82C5-49FA734D73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CC8F70-DCE5-49D5-AF0C-B48B796A6A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32718B-9F67-4E0F-809C-B8E662E8C0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DFFE81-9D2D-4D28-AF62-E6804F5871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83F794-A794-4C60-BB9C-CD3815FE7B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FFF7BE-0D39-459F-A5BC-7A23F1E588A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7"/>
          <p:cNvGrpSpPr/>
          <p:nvPr/>
        </p:nvGrpSpPr>
        <p:grpSpPr>
          <a:xfrm>
            <a:off x="914400" y="1219320"/>
            <a:ext cx="7238880" cy="4343400"/>
            <a:chOff x="914400" y="1219320"/>
            <a:chExt cx="7238880" cy="4343400"/>
          </a:xfrm>
        </p:grpSpPr>
        <p:pic>
          <p:nvPicPr>
            <p:cNvPr id="42" name="Chart 3" descr=""/>
            <p:cNvPicPr/>
            <p:nvPr/>
          </p:nvPicPr>
          <p:blipFill>
            <a:blip r:embed="rId1"/>
            <a:stretch/>
          </p:blipFill>
          <p:spPr>
            <a:xfrm>
              <a:off x="914400" y="1219320"/>
              <a:ext cx="7238880" cy="4343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Straight Connector 6"/>
            <p:cNvSpPr/>
            <p:nvPr/>
          </p:nvSpPr>
          <p:spPr>
            <a:xfrm>
              <a:off x="1681200" y="4346280"/>
              <a:ext cx="618336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Straight Connector 10"/>
            <p:cNvSpPr/>
            <p:nvPr/>
          </p:nvSpPr>
          <p:spPr>
            <a:xfrm flipV="1">
              <a:off x="2726280" y="1398960"/>
              <a:ext cx="2880" cy="34678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Box 12"/>
            <p:cNvSpPr/>
            <p:nvPr/>
          </p:nvSpPr>
          <p:spPr>
            <a:xfrm>
              <a:off x="3488760" y="3632400"/>
              <a:ext cx="2758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Treatment  inf_res_3dp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Box 14"/>
            <p:cNvSpPr/>
            <p:nvPr/>
          </p:nvSpPr>
          <p:spPr>
            <a:xfrm>
              <a:off x="3393720" y="4066200"/>
              <a:ext cx="2758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Treatment  inf_sus_3dp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Box 15"/>
            <p:cNvSpPr/>
            <p:nvPr/>
          </p:nvSpPr>
          <p:spPr>
            <a:xfrm>
              <a:off x="1681200" y="3652560"/>
              <a:ext cx="2758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Treatment  c_sus_3dp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Box 16"/>
            <p:cNvSpPr/>
            <p:nvPr/>
          </p:nvSpPr>
          <p:spPr>
            <a:xfrm>
              <a:off x="1871640" y="3892680"/>
              <a:ext cx="2758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Treatment  c_res_3dp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9" name="TextBox 18"/>
          <p:cNvSpPr/>
          <p:nvPr/>
        </p:nvSpPr>
        <p:spPr>
          <a:xfrm>
            <a:off x="457200" y="390600"/>
            <a:ext cx="289548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X-axis:   PCA component 1 (42.98% variance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Y-axis:    PCA component 2 (30.51% variance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Conditions: RMA_3dpi, Default Interpretatio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9"/>
          <p:cNvSpPr/>
          <p:nvPr/>
        </p:nvSpPr>
        <p:spPr>
          <a:xfrm>
            <a:off x="3505320" y="5334120"/>
            <a:ext cx="297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CA  component 1 (42.98% variance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20"/>
          <p:cNvSpPr/>
          <p:nvPr/>
        </p:nvSpPr>
        <p:spPr>
          <a:xfrm>
            <a:off x="1371600" y="6095880"/>
            <a:ext cx="7315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1. Principal component analysis (PCA) plot of cowpea genome response to nematode infection at 3 dpi. Each dot represents the mean of a particular condition (treatment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TextBox 22" descr=""/>
          <p:cNvPicPr/>
          <p:nvPr/>
        </p:nvPicPr>
        <p:blipFill>
          <a:blip r:embed="rId2"/>
          <a:stretch/>
        </p:blipFill>
        <p:spPr>
          <a:xfrm>
            <a:off x="835200" y="1822320"/>
            <a:ext cx="560160" cy="2573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04T21:31:31Z</dcterms:created>
  <dc:creator>Sayan</dc:creator>
  <dc:description/>
  <dc:language>en-US</dc:language>
  <cp:lastModifiedBy>sayan</cp:lastModifiedBy>
  <dcterms:modified xsi:type="dcterms:W3CDTF">2010-08-17T00:36:14Z</dcterms:modified>
  <cp:revision>6</cp:revision>
  <dc:subject/>
  <dc:title>Slide 1</dc:title>
</cp:coreProperties>
</file>